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7D8AE-4C56-49C0-B9EF-448C5B5FF4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C4577-1386-4B52-81CE-260866DA3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68750-1B66-4B73-B6D1-CBF14EEC72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B0AA6-6620-4EF0-9C36-E3C6886621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47FF3-238B-4C99-8A83-85F19D330A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43C53-EFC1-4E8D-98CB-0ECB665D58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8980D-51FA-4752-9586-2630A00EFA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E1495-7ADF-46B0-A409-E9FDAC3F2B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7C8E9-33DB-44CF-9E2F-E7E9CF233B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F0ED0-3BFA-483B-B8B8-372A7C431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688AB-1893-41F7-81D4-5CD784C049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5FCB8-65A8-4AF4-ADE1-2EC6CBEB55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44C578-36A5-4A75-AABD-A6CF709F0D6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slideLayout" Target="../slideLayouts/slideLayout1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457200" y="380880"/>
            <a:ext cx="624996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"/>
          <p:cNvSpPr/>
          <p:nvPr/>
        </p:nvSpPr>
        <p:spPr>
          <a:xfrm>
            <a:off x="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886200" y="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0" y="388620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0" y="609588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380880" y="457200"/>
            <a:ext cx="3854520" cy="316224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2"/>
          <a:stretch/>
        </p:blipFill>
        <p:spPr>
          <a:xfrm>
            <a:off x="4317840" y="380880"/>
            <a:ext cx="2540160" cy="1130400"/>
          </a:xfrm>
          <a:prstGeom prst="rect">
            <a:avLst/>
          </a:prstGeom>
          <a:ln w="0">
            <a:noFill/>
          </a:ln>
        </p:spPr>
      </p:pic>
      <p:pic>
        <p:nvPicPr>
          <p:cNvPr id="80" name="" descr=""/>
          <p:cNvPicPr/>
          <p:nvPr/>
        </p:nvPicPr>
        <p:blipFill>
          <a:blip r:embed="rId3"/>
          <a:stretch/>
        </p:blipFill>
        <p:spPr>
          <a:xfrm>
            <a:off x="1676520" y="3581280"/>
            <a:ext cx="5181480" cy="2170080"/>
          </a:xfrm>
          <a:prstGeom prst="rect">
            <a:avLst/>
          </a:prstGeom>
          <a:ln w="0">
            <a:noFill/>
          </a:ln>
        </p:spPr>
      </p:pic>
      <p:pic>
        <p:nvPicPr>
          <p:cNvPr id="81" name="" descr=""/>
          <p:cNvPicPr/>
          <p:nvPr/>
        </p:nvPicPr>
        <p:blipFill>
          <a:blip r:embed="rId4"/>
          <a:stretch/>
        </p:blipFill>
        <p:spPr>
          <a:xfrm>
            <a:off x="914400" y="6324480"/>
            <a:ext cx="2548080" cy="2819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0" y="685800"/>
            <a:ext cx="7042320" cy="7238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87480" y="304920"/>
            <a:ext cx="6770520" cy="845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525600" y="533520"/>
            <a:ext cx="633240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990720" y="304920"/>
            <a:ext cx="4862520" cy="8381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04920" y="228600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2133720" y="0"/>
            <a:ext cx="2171520" cy="186228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990720" y="2133720"/>
            <a:ext cx="4978440" cy="6638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135000" y="380880"/>
            <a:ext cx="6723000" cy="830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192240" y="299880"/>
            <a:ext cx="6476760" cy="8542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"/>
          <p:cNvSpPr/>
          <p:nvPr/>
        </p:nvSpPr>
        <p:spPr>
          <a:xfrm>
            <a:off x="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267080" y="8777160"/>
            <a:ext cx="25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97180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304920" y="380880"/>
            <a:ext cx="2793960" cy="170352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2"/>
          <a:stretch/>
        </p:blipFill>
        <p:spPr>
          <a:xfrm>
            <a:off x="3276720" y="457200"/>
            <a:ext cx="3174840" cy="296388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0" y="342900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838080" y="3657600"/>
            <a:ext cx="5562720" cy="501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8T23:53:00Z</dcterms:created>
  <dc:creator>Ming Yi</dc:creator>
  <dc:description/>
  <dc:language>en-US</dc:language>
  <cp:lastModifiedBy>Ming Yi</cp:lastModifiedBy>
  <dcterms:modified xsi:type="dcterms:W3CDTF">2012-02-09T05:52:27Z</dcterms:modified>
  <cp:revision>8</cp:revision>
  <dc:subject/>
  <dc:title>Slide 1</dc:title>
</cp:coreProperties>
</file>